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879B3-A295-4578-8844-4F1572D2E04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F6CF74-4860-4E47-BB77-7C189BD57D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4C8BB8-D93A-4DE6-BEBA-AADC72277B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6C022A-5F64-48A8-BEAD-A7CAB996F6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D9ED73-8AF8-48DD-A07A-D1F4FB1E5D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84A4DB-1AFB-4110-B2BB-BD3BF8E833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CCF5EA-0522-4B1B-BE08-3929C818CF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EEFA8-585D-4D47-8BB4-F34FF69A22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C43837-4185-498E-AC71-722AE01C61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21073F-E7E6-452D-978B-83F41C7996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52945B-04D9-4022-BDE2-A482BDE2B1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075B99-E04C-43CA-B8E5-377BF61A5F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8686C3-54EF-450F-B951-83765B662DE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103400" y="539640"/>
          <a:ext cx="4651200" cy="4683240"/>
        </p:xfrm>
        <a:graphic>
          <a:graphicData uri="http://schemas.openxmlformats.org/drawingml/2006/table">
            <a:tbl>
              <a:tblPr/>
              <a:tblGrid>
                <a:gridCol w="1089000"/>
                <a:gridCol w="1260360"/>
                <a:gridCol w="1079640"/>
                <a:gridCol w="1222200"/>
              </a:tblGrid>
              <a:tr h="249480"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ference Gen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 algn="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5">
                  <a:txBody>
                    <a:bodyPr lIns="90000" rIns="90000" tIns="46800" bIns="46800" anchor="t">
                      <a:noAutofit/>
                    </a:bodyPr>
                    <a:p>
                      <a:pPr algn="r" rtl="1"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pPr algn="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494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S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RN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s03928990_g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pPr algn="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pPr algn="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494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8446973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pPr algn="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pPr algn="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494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plpo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(36b4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4351370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pPr algn="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pPr algn="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90320">
                <a:tc gridSpan="2"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tected Gene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 algn="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pPr algn="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pPr algn="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050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l1b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43422/8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rc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1329362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50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l2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(MCP1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441242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sr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446214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50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l5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RANTES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1302428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lec10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CD206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4448892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50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l8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MCP2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1297183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sp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438023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50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xcl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445235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mr1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(F4/80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802529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50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xcl1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444534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rg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475988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50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l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446190-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par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1184322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50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nf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443258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lc2a4 (Glut4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1245502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50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d16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474091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bp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445878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94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i3l3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Ym1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657889_m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bp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514283_s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94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tnla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Fizz1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445109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bpb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843 434_s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903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gl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00460844_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 algn="r" rtl="1"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 algn="r" rtl="1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3251160" y="8656560"/>
            <a:ext cx="3500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able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07T12:37:17Z</dcterms:created>
  <dc:creator>nov</dc:creator>
  <dc:description/>
  <dc:language>en-US</dc:language>
  <cp:lastModifiedBy>nov</cp:lastModifiedBy>
  <dcterms:modified xsi:type="dcterms:W3CDTF">2012-12-07T12:42:48Z</dcterms:modified>
  <cp:revision>10</cp:revision>
  <dc:subject/>
  <dc:title>Slide 1</dc:title>
</cp:coreProperties>
</file>